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charts/colors6.xml" ContentType="application/vnd.ms-office.chartcolorstyl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Override PartName="/ppt/charts/colors5.xml" ContentType="application/vnd.ms-office.chartcolorstyle+xml"/>
  <Override PartName="/ppt/charts/colors4.xml" ContentType="application/vnd.ms-office.chartcolorstyle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charts/colors3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style6.xml" ContentType="application/vnd.ms-office.chartstyle+xml"/>
  <Override PartName="/ppt/charts/style5.xml" ContentType="application/vnd.ms-office.chartstyl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charts/style3.xml" ContentType="application/vnd.ms-office.chartstyle+xml"/>
  <Override PartName="/ppt/charts/style4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0" r:id="rId2"/>
    <p:sldId id="262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8968B"/>
    <a:srgbClr val="3D918D"/>
    <a:srgbClr val="111CFB"/>
    <a:srgbClr val="008E4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2804" autoAdjust="0"/>
    <p:restoredTop sz="94675" autoAdjust="0"/>
  </p:normalViewPr>
  <p:slideViewPr>
    <p:cSldViewPr snapToGrid="0">
      <p:cViewPr>
        <p:scale>
          <a:sx n="93" d="100"/>
          <a:sy n="93" d="100"/>
        </p:scale>
        <p:origin x="-994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C:\Users\Suzie\Documents\LAB%20WORK\Projects\T%20cell%20paper\my%20T%20cell%20activation%20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achi\Documents\ALL%20data\Thymus%20staining\29May14%20Annexin%20V%20in%20DP%20SP%20thymus\29May14%20Annexin%20V%20analysis%20in%20DP%20SP%20cell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uzie\Dropbox\T%20cell%20paper\Raw%20data\CD25%20CD44%20re-%20analysis%2012May14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2" Type="http://schemas.microsoft.com/office/2011/relationships/chartColorStyle" Target="colors6.xml"/><Relationship Id="rId1" Type="http://schemas.openxmlformats.org/officeDocument/2006/relationships/oleObject" Target="file:///C:\Users\Suzie\Documents\LAB%20WORK\Projects\T%20cell%20paper\my%20T%20cell%20activation%202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C:\Users\Suzie\Documents\LAB%20WORK\Projects\T%20cell%20paper\my%20T%20cell%20activation%202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file:///C:\Users\Suzie\Documents\LAB%20WORK\Projects\T%20cell%20paper\my%20T%20cell%20activation%20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>
        <c:manualLayout>
          <c:layoutTarget val="inner"/>
          <c:xMode val="edge"/>
          <c:yMode val="edge"/>
          <c:x val="0.22439785276673144"/>
          <c:y val="0.21081607795371496"/>
          <c:w val="0.68352178525255447"/>
          <c:h val="0.62494462878183332"/>
        </c:manualLayout>
      </c:layout>
      <c:barChart>
        <c:barDir val="col"/>
        <c:grouping val="clustered"/>
        <c:ser>
          <c:idx val="0"/>
          <c:order val="0"/>
          <c:tx>
            <c:strRef>
              <c:f>'Cell number'!$D$9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'Cell number'!$E$95:$I$95</c:f>
                <c:numCache>
                  <c:formatCode>General</c:formatCode>
                  <c:ptCount val="5"/>
                  <c:pt idx="0">
                    <c:v>0.87732710954515503</c:v>
                  </c:pt>
                  <c:pt idx="1">
                    <c:v>2.0176679135882987</c:v>
                  </c:pt>
                  <c:pt idx="2">
                    <c:v>1.6609242980369463</c:v>
                  </c:pt>
                  <c:pt idx="3">
                    <c:v>3.8101733493872669</c:v>
                  </c:pt>
                  <c:pt idx="4">
                    <c:v>2.5030004851320782</c:v>
                  </c:pt>
                </c:numCache>
              </c:numRef>
            </c:plus>
            <c:minus>
              <c:numRef>
                <c:f>'Cell number'!$E$95:$I$95</c:f>
                <c:numCache>
                  <c:formatCode>General</c:formatCode>
                  <c:ptCount val="5"/>
                  <c:pt idx="0">
                    <c:v>0.87732710954515503</c:v>
                  </c:pt>
                  <c:pt idx="1">
                    <c:v>2.0176679135882987</c:v>
                  </c:pt>
                  <c:pt idx="2">
                    <c:v>1.6609242980369463</c:v>
                  </c:pt>
                  <c:pt idx="3">
                    <c:v>3.8101733493872669</c:v>
                  </c:pt>
                  <c:pt idx="4">
                    <c:v>2.50300048513207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Cell number'!$E$59:$H$59</c:f>
              <c:numCache>
                <c:formatCode>0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'Cell number'!$E$92:$H$92</c:f>
              <c:numCache>
                <c:formatCode>0.00</c:formatCode>
                <c:ptCount val="4"/>
                <c:pt idx="0">
                  <c:v>16.372</c:v>
                </c:pt>
                <c:pt idx="1">
                  <c:v>15.255333333333336</c:v>
                </c:pt>
                <c:pt idx="2">
                  <c:v>19.218666666666664</c:v>
                </c:pt>
                <c:pt idx="3">
                  <c:v>13.1093333333333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C65-47FE-A2D5-1EC1AC4DE21C}"/>
            </c:ext>
          </c:extLst>
        </c:ser>
        <c:ser>
          <c:idx val="1"/>
          <c:order val="1"/>
          <c:tx>
            <c:strRef>
              <c:f>'Cell number'!$D$93</c:f>
              <c:strCache>
                <c:ptCount val="1"/>
                <c:pt idx="0">
                  <c:v>mutant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12700"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'Cell number'!$E$96:$I$96</c:f>
                <c:numCache>
                  <c:formatCode>General</c:formatCode>
                  <c:ptCount val="5"/>
                  <c:pt idx="0">
                    <c:v>0.96153795457862379</c:v>
                  </c:pt>
                  <c:pt idx="1">
                    <c:v>1.359120864312489</c:v>
                  </c:pt>
                  <c:pt idx="2">
                    <c:v>1.6797570686036145</c:v>
                  </c:pt>
                  <c:pt idx="3">
                    <c:v>1.9199905753737014</c:v>
                  </c:pt>
                  <c:pt idx="4">
                    <c:v>1.0027804203456334</c:v>
                  </c:pt>
                </c:numCache>
              </c:numRef>
            </c:plus>
            <c:minus>
              <c:numRef>
                <c:f>'Cell number'!$E$96:$I$96</c:f>
                <c:numCache>
                  <c:formatCode>General</c:formatCode>
                  <c:ptCount val="5"/>
                  <c:pt idx="0">
                    <c:v>0.96153795457862379</c:v>
                  </c:pt>
                  <c:pt idx="1">
                    <c:v>1.359120864312489</c:v>
                  </c:pt>
                  <c:pt idx="2">
                    <c:v>1.6797570686036145</c:v>
                  </c:pt>
                  <c:pt idx="3">
                    <c:v>1.9199905753737014</c:v>
                  </c:pt>
                  <c:pt idx="4">
                    <c:v>1.00278042034563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Cell number'!$E$59:$H$59</c:f>
              <c:numCache>
                <c:formatCode>0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'Cell number'!$E$93:$H$93</c:f>
              <c:numCache>
                <c:formatCode>0.00</c:formatCode>
                <c:ptCount val="4"/>
                <c:pt idx="0">
                  <c:v>5.9186666666666676</c:v>
                </c:pt>
                <c:pt idx="1">
                  <c:v>6.3966666666666674</c:v>
                </c:pt>
                <c:pt idx="2">
                  <c:v>10.381333333333334</c:v>
                </c:pt>
                <c:pt idx="3">
                  <c:v>11.430666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C65-47FE-A2D5-1EC1AC4DE21C}"/>
            </c:ext>
          </c:extLst>
        </c:ser>
        <c:dLbls/>
        <c:axId val="106375424"/>
        <c:axId val="106389888"/>
      </c:barChart>
      <c:catAx>
        <c:axId val="106375424"/>
        <c:scaling>
          <c:orientation val="minMax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  <a:endParaRPr lang="en-GB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0" sourceLinked="1"/>
        <c:majorTickMark val="none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389888"/>
        <c:crosses val="autoZero"/>
        <c:auto val="1"/>
        <c:lblAlgn val="ctr"/>
        <c:lblOffset val="100"/>
        <c:tickMarkSkip val="1"/>
      </c:catAx>
      <c:valAx>
        <c:axId val="106389888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r>
                  <a:rPr lang="en-GB" sz="800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of </a:t>
                </a:r>
                <a:r>
                  <a:rPr lang="en-GB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4+</a:t>
                </a:r>
                <a:r>
                  <a:rPr lang="en-GB" sz="800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</a:p>
            </c:rich>
          </c:tx>
          <c:layout>
            <c:manualLayout>
              <c:xMode val="edge"/>
              <c:yMode val="edge"/>
              <c:x val="5.8927905341427812E-2"/>
              <c:y val="0.29218922816301957"/>
            </c:manualLayout>
          </c:layout>
          <c:spPr>
            <a:noFill/>
            <a:ln>
              <a:noFill/>
            </a:ln>
            <a:effectLst/>
          </c:spPr>
        </c:title>
        <c:numFmt formatCode="#,##0" sourceLinked="0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3754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plotArea>
      <c:layout>
        <c:manualLayout>
          <c:layoutTarget val="inner"/>
          <c:xMode val="edge"/>
          <c:yMode val="edge"/>
          <c:x val="0.21575949692111621"/>
          <c:y val="0.10263951373438691"/>
          <c:w val="0.60069187352066544"/>
          <c:h val="0.75192994926528078"/>
        </c:manualLayout>
      </c:layout>
      <c:barChart>
        <c:barDir val="col"/>
        <c:grouping val="clustered"/>
        <c:ser>
          <c:idx val="0"/>
          <c:order val="0"/>
          <c:tx>
            <c:strRef>
              <c:f>all!$B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lt1"/>
            </a:solidFill>
            <a:ln w="12700" cap="flat" cmpd="sng" algn="ctr">
              <a:solidFill>
                <a:schemeClr val="dk1"/>
              </a:solidFill>
              <a:prstDash val="solid"/>
            </a:ln>
            <a:effectLst/>
          </c:spPr>
          <c:errBars>
            <c:errBarType val="both"/>
            <c:errValType val="cust"/>
            <c:plus>
              <c:numRef>
                <c:f>all!$D$10:$F$10</c:f>
                <c:numCache>
                  <c:formatCode>General</c:formatCode>
                  <c:ptCount val="3"/>
                  <c:pt idx="0">
                    <c:v>2.3866433890857373</c:v>
                  </c:pt>
                  <c:pt idx="1">
                    <c:v>5.4325819521353447</c:v>
                  </c:pt>
                  <c:pt idx="2">
                    <c:v>10.792279493539192</c:v>
                  </c:pt>
                </c:numCache>
              </c:numRef>
            </c:plus>
            <c:minus>
              <c:numRef>
                <c:f>all!$D$10:$F$10</c:f>
                <c:numCache>
                  <c:formatCode>General</c:formatCode>
                  <c:ptCount val="3"/>
                  <c:pt idx="0">
                    <c:v>2.3866433890857373</c:v>
                  </c:pt>
                  <c:pt idx="1">
                    <c:v>5.4325819521353447</c:v>
                  </c:pt>
                  <c:pt idx="2">
                    <c:v>10.792279493539192</c:v>
                  </c:pt>
                </c:numCache>
              </c:numRef>
            </c:minus>
          </c:errBars>
          <c:cat>
            <c:strRef>
              <c:f>all!$D$15:$F$15</c:f>
              <c:strCache>
                <c:ptCount val="3"/>
                <c:pt idx="0">
                  <c:v>DP</c:v>
                </c:pt>
                <c:pt idx="1">
                  <c:v>CD4</c:v>
                </c:pt>
                <c:pt idx="2">
                  <c:v>CD8</c:v>
                </c:pt>
              </c:strCache>
            </c:strRef>
          </c:cat>
          <c:val>
            <c:numRef>
              <c:f>all!$D$9:$F$9</c:f>
              <c:numCache>
                <c:formatCode>General</c:formatCode>
                <c:ptCount val="3"/>
                <c:pt idx="0">
                  <c:v>9.6333333333333329</c:v>
                </c:pt>
                <c:pt idx="1">
                  <c:v>9.3366666666666696</c:v>
                </c:pt>
                <c:pt idx="2">
                  <c:v>29.9516666666666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7EC-4122-8187-51FBE9800C17}"/>
            </c:ext>
          </c:extLst>
        </c:ser>
        <c:ser>
          <c:idx val="1"/>
          <c:order val="1"/>
          <c:tx>
            <c:strRef>
              <c:f>all!$B$15</c:f>
              <c:strCache>
                <c:ptCount val="1"/>
                <c:pt idx="0">
                  <c:v>Fbxo7 KO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12700" cap="flat" cmpd="sng" algn="ctr">
              <a:solidFill>
                <a:schemeClr val="tx1"/>
              </a:solidFill>
              <a:prstDash val="solid"/>
            </a:ln>
            <a:effectLst/>
          </c:spPr>
          <c:errBars>
            <c:errBarType val="both"/>
            <c:errValType val="cust"/>
            <c:plus>
              <c:numRef>
                <c:f>all!$D$22:$F$22</c:f>
                <c:numCache>
                  <c:formatCode>General</c:formatCode>
                  <c:ptCount val="3"/>
                  <c:pt idx="0">
                    <c:v>2.2553558477544109</c:v>
                  </c:pt>
                  <c:pt idx="1">
                    <c:v>5.1615046255912658</c:v>
                  </c:pt>
                  <c:pt idx="2">
                    <c:v>18.93908603919418</c:v>
                  </c:pt>
                </c:numCache>
              </c:numRef>
            </c:plus>
            <c:minus>
              <c:numRef>
                <c:f>all!$D$22:$F$22</c:f>
                <c:numCache>
                  <c:formatCode>General</c:formatCode>
                  <c:ptCount val="3"/>
                  <c:pt idx="0">
                    <c:v>2.2553558477544109</c:v>
                  </c:pt>
                  <c:pt idx="1">
                    <c:v>5.1615046255912658</c:v>
                  </c:pt>
                  <c:pt idx="2">
                    <c:v>18.93908603919418</c:v>
                  </c:pt>
                </c:numCache>
              </c:numRef>
            </c:minus>
          </c:errBars>
          <c:cat>
            <c:strRef>
              <c:f>all!$D$15:$F$15</c:f>
              <c:strCache>
                <c:ptCount val="3"/>
                <c:pt idx="0">
                  <c:v>DP</c:v>
                </c:pt>
                <c:pt idx="1">
                  <c:v>CD4</c:v>
                </c:pt>
                <c:pt idx="2">
                  <c:v>CD8</c:v>
                </c:pt>
              </c:strCache>
            </c:strRef>
          </c:cat>
          <c:val>
            <c:numRef>
              <c:f>all!$D$21:$F$21</c:f>
              <c:numCache>
                <c:formatCode>General</c:formatCode>
                <c:ptCount val="3"/>
                <c:pt idx="0">
                  <c:v>8.8640000000000008</c:v>
                </c:pt>
                <c:pt idx="1">
                  <c:v>11.564000000000002</c:v>
                </c:pt>
                <c:pt idx="2">
                  <c:v>29.826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7EC-4122-8187-51FBE9800C17}"/>
            </c:ext>
          </c:extLst>
        </c:ser>
        <c:dLbls/>
        <c:axId val="106418944"/>
        <c:axId val="106420480"/>
      </c:barChart>
      <c:catAx>
        <c:axId val="106418944"/>
        <c:scaling>
          <c:orientation val="minMax"/>
        </c:scaling>
        <c:axPos val="b"/>
        <c:numFmt formatCode="General" sourceLinked="0"/>
        <c:majorTickMark val="none"/>
        <c:minorTickMark val="out"/>
        <c:tickLblPos val="nextTo"/>
        <c:spPr>
          <a:noFill/>
          <a:ln w="12700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800"/>
            </a:pPr>
            <a:endParaRPr lang="en-US"/>
          </a:p>
        </c:txPr>
        <c:crossAx val="106420480"/>
        <c:crosses val="autoZero"/>
        <c:auto val="1"/>
        <c:lblAlgn val="ctr"/>
        <c:lblOffset val="100"/>
      </c:catAx>
      <c:valAx>
        <c:axId val="10642048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800" b="0"/>
                </a:pPr>
                <a:r>
                  <a:rPr lang="en-GB" sz="800" b="0"/>
                  <a:t>Annexin V+ cells (%)</a:t>
                </a:r>
              </a:p>
            </c:rich>
          </c:tx>
          <c:layout>
            <c:manualLayout>
              <c:xMode val="edge"/>
              <c:yMode val="edge"/>
              <c:x val="2.9771569693885645E-2"/>
              <c:y val="0.12059999554899446"/>
            </c:manualLayout>
          </c:layout>
        </c:title>
        <c:numFmt formatCode="General" sourceLinked="1"/>
        <c:tickLblPos val="nextTo"/>
        <c:spPr>
          <a:noFill/>
          <a:ln w="12700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800"/>
            </a:pPr>
            <a:endParaRPr lang="en-US"/>
          </a:p>
        </c:txPr>
        <c:crossAx val="106418944"/>
        <c:crosses val="autoZero"/>
        <c:crossBetween val="between"/>
      </c:valAx>
    </c:plotArea>
    <c:plotVisOnly val="1"/>
    <c:dispBlanksAs val="gap"/>
  </c:chart>
  <c:spPr>
    <a:ln>
      <a:noFill/>
    </a:ln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plotArea>
      <c:layout>
        <c:manualLayout>
          <c:layoutTarget val="inner"/>
          <c:xMode val="edge"/>
          <c:yMode val="edge"/>
          <c:x val="0.20429183553686228"/>
          <c:y val="0.13285060651202385"/>
          <c:w val="0.76649166803928082"/>
          <c:h val="0.74522515743552686"/>
        </c:manualLayout>
      </c:layout>
      <c:barChart>
        <c:barDir val="col"/>
        <c:grouping val="clustered"/>
        <c:ser>
          <c:idx val="0"/>
          <c:order val="0"/>
          <c:tx>
            <c:strRef>
              <c:f>'old mice &gt;10 weeks old'!$A$20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lt1"/>
            </a:solidFill>
            <a:ln w="12700" cap="flat" cmpd="sng" algn="ctr">
              <a:solidFill>
                <a:schemeClr val="dk1"/>
              </a:solidFill>
              <a:prstDash val="solid"/>
            </a:ln>
            <a:effectLst/>
          </c:spPr>
          <c:errBars>
            <c:errBarType val="both"/>
            <c:errValType val="cust"/>
            <c:plus>
              <c:numRef>
                <c:f>'old mice &gt;10 weeks old'!$C$14:$F$14</c:f>
                <c:numCache>
                  <c:formatCode>General</c:formatCode>
                  <c:ptCount val="4"/>
                  <c:pt idx="0">
                    <c:v>7.4994374334467029</c:v>
                  </c:pt>
                  <c:pt idx="1">
                    <c:v>3.3419017449241801</c:v>
                  </c:pt>
                  <c:pt idx="2">
                    <c:v>10.289156781424168</c:v>
                  </c:pt>
                  <c:pt idx="3">
                    <c:v>6.7232305546447684</c:v>
                  </c:pt>
                </c:numCache>
              </c:numRef>
            </c:plus>
            <c:minus>
              <c:numRef>
                <c:f>'old mice &gt;10 weeks old'!$C$14:$F$14</c:f>
                <c:numCache>
                  <c:formatCode>General</c:formatCode>
                  <c:ptCount val="4"/>
                  <c:pt idx="0">
                    <c:v>7.4994374334467029</c:v>
                  </c:pt>
                  <c:pt idx="1">
                    <c:v>3.3419017449241801</c:v>
                  </c:pt>
                  <c:pt idx="2">
                    <c:v>10.289156781424168</c:v>
                  </c:pt>
                  <c:pt idx="3">
                    <c:v>6.7232305546447684</c:v>
                  </c:pt>
                </c:numCache>
              </c:numRef>
            </c:minus>
          </c:errBars>
          <c:cat>
            <c:strRef>
              <c:f>'old mice &gt;10 weeks old'!$C$19:$F$19</c:f>
              <c:strCache>
                <c:ptCount val="4"/>
                <c:pt idx="0">
                  <c:v>DN1</c:v>
                </c:pt>
                <c:pt idx="1">
                  <c:v>DN2</c:v>
                </c:pt>
                <c:pt idx="2">
                  <c:v>DN3</c:v>
                </c:pt>
                <c:pt idx="3">
                  <c:v>DN4</c:v>
                </c:pt>
              </c:strCache>
            </c:strRef>
          </c:cat>
          <c:val>
            <c:numRef>
              <c:f>'old mice &gt;10 weeks old'!$C$20:$F$20</c:f>
              <c:numCache>
                <c:formatCode>General</c:formatCode>
                <c:ptCount val="4"/>
                <c:pt idx="0">
                  <c:v>18.382727272727266</c:v>
                </c:pt>
                <c:pt idx="1">
                  <c:v>6.3654545454545444</c:v>
                </c:pt>
                <c:pt idx="2">
                  <c:v>50.884545454545439</c:v>
                </c:pt>
                <c:pt idx="3">
                  <c:v>24.8309090909090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6D9-497D-A157-8BB798D84379}"/>
            </c:ext>
          </c:extLst>
        </c:ser>
        <c:ser>
          <c:idx val="1"/>
          <c:order val="1"/>
          <c:tx>
            <c:strRef>
              <c:f>'old mice &gt;10 weeks old'!$A$21</c:f>
              <c:strCache>
                <c:ptCount val="1"/>
                <c:pt idx="0">
                  <c:v>Fbxo7LacZ/LacZ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12700" cap="flat" cmpd="sng" algn="ctr">
              <a:solidFill>
                <a:schemeClr val="dk1">
                  <a:shade val="50000"/>
                </a:schemeClr>
              </a:solidFill>
              <a:prstDash val="solid"/>
            </a:ln>
            <a:effectLst/>
          </c:spPr>
          <c:errBars>
            <c:errBarType val="both"/>
            <c:errValType val="cust"/>
            <c:plus>
              <c:numRef>
                <c:f>'old mice &gt;10 weeks old'!$J$14:$M$14</c:f>
                <c:numCache>
                  <c:formatCode>General</c:formatCode>
                  <c:ptCount val="4"/>
                  <c:pt idx="0">
                    <c:v>9.18929139616524</c:v>
                  </c:pt>
                  <c:pt idx="1">
                    <c:v>3.1683196004994665</c:v>
                  </c:pt>
                  <c:pt idx="2">
                    <c:v>11.740462899345536</c:v>
                  </c:pt>
                  <c:pt idx="3">
                    <c:v>5.4815440757641793</c:v>
                  </c:pt>
                </c:numCache>
              </c:numRef>
            </c:plus>
            <c:minus>
              <c:numRef>
                <c:f>'old mice &gt;10 weeks old'!$J$14:$M$14</c:f>
                <c:numCache>
                  <c:formatCode>General</c:formatCode>
                  <c:ptCount val="4"/>
                  <c:pt idx="0">
                    <c:v>9.18929139616524</c:v>
                  </c:pt>
                  <c:pt idx="1">
                    <c:v>3.1683196004994665</c:v>
                  </c:pt>
                  <c:pt idx="2">
                    <c:v>11.740462899345536</c:v>
                  </c:pt>
                  <c:pt idx="3">
                    <c:v>5.4815440757641793</c:v>
                  </c:pt>
                </c:numCache>
              </c:numRef>
            </c:minus>
          </c:errBars>
          <c:cat>
            <c:strRef>
              <c:f>'old mice &gt;10 weeks old'!$C$19:$F$19</c:f>
              <c:strCache>
                <c:ptCount val="4"/>
                <c:pt idx="0">
                  <c:v>DN1</c:v>
                </c:pt>
                <c:pt idx="1">
                  <c:v>DN2</c:v>
                </c:pt>
                <c:pt idx="2">
                  <c:v>DN3</c:v>
                </c:pt>
                <c:pt idx="3">
                  <c:v>DN4</c:v>
                </c:pt>
              </c:strCache>
            </c:strRef>
          </c:cat>
          <c:val>
            <c:numRef>
              <c:f>'old mice &gt;10 weeks old'!$C$21:$F$21</c:f>
              <c:numCache>
                <c:formatCode>General</c:formatCode>
                <c:ptCount val="4"/>
                <c:pt idx="0">
                  <c:v>19.361818181818187</c:v>
                </c:pt>
                <c:pt idx="1">
                  <c:v>6.3790909090909089</c:v>
                </c:pt>
                <c:pt idx="2">
                  <c:v>51.430909090909097</c:v>
                </c:pt>
                <c:pt idx="3">
                  <c:v>23.2263636363636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6D9-497D-A157-8BB798D84379}"/>
            </c:ext>
          </c:extLst>
        </c:ser>
        <c:dLbls/>
        <c:axId val="106333312"/>
        <c:axId val="106334848"/>
      </c:barChart>
      <c:catAx>
        <c:axId val="106333312"/>
        <c:scaling>
          <c:orientation val="minMax"/>
        </c:scaling>
        <c:axPos val="b"/>
        <c:numFmt formatCode="General" sourceLinked="0"/>
        <c:majorTickMark val="none"/>
        <c:minorTickMark val="out"/>
        <c:tickLblPos val="nextTo"/>
        <c:spPr>
          <a:ln w="12700">
            <a:solidFill>
              <a:schemeClr val="tx1"/>
            </a:solidFill>
          </a:ln>
        </c:spPr>
        <c:crossAx val="106334848"/>
        <c:crosses val="autoZero"/>
        <c:auto val="1"/>
        <c:lblAlgn val="ctr"/>
        <c:lblOffset val="100"/>
      </c:catAx>
      <c:valAx>
        <c:axId val="106334848"/>
        <c:scaling>
          <c:orientation val="minMax"/>
          <c:max val="100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of DN thymocytes</a:t>
                </a:r>
              </a:p>
            </c:rich>
          </c:tx>
          <c:layout>
            <c:manualLayout>
              <c:xMode val="edge"/>
              <c:yMode val="edge"/>
              <c:x val="6.9059113654764744E-3"/>
              <c:y val="0.15210416715885963"/>
            </c:manualLayout>
          </c:layout>
        </c:title>
        <c:numFmt formatCode="General" sourceLinked="1"/>
        <c:tickLblPos val="nextTo"/>
        <c:spPr>
          <a:ln w="12700">
            <a:solidFill>
              <a:sysClr val="windowText" lastClr="000000"/>
            </a:solidFill>
          </a:ln>
        </c:spPr>
        <c:crossAx val="106333312"/>
        <c:crosses val="autoZero"/>
        <c:crossBetween val="between"/>
      </c:valAx>
    </c:plotArea>
    <c:plotVisOnly val="1"/>
    <c:dispBlanksAs val="gap"/>
  </c:chart>
  <c:spPr>
    <a:ln>
      <a:noFill/>
    </a:ln>
  </c:spPr>
  <c:txPr>
    <a:bodyPr/>
    <a:lstStyle/>
    <a:p>
      <a:pPr>
        <a:defRPr sz="800" b="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>
        <c:manualLayout>
          <c:layoutTarget val="inner"/>
          <c:xMode val="edge"/>
          <c:yMode val="edge"/>
          <c:x val="0.22092768452103173"/>
          <c:y val="0.22214730876625258"/>
          <c:w val="0.66003454303546738"/>
          <c:h val="0.6112743219888146"/>
        </c:manualLayout>
      </c:layout>
      <c:scatterChart>
        <c:scatterStyle val="smoothMarker"/>
        <c:ser>
          <c:idx val="0"/>
          <c:order val="0"/>
          <c:tx>
            <c:strRef>
              <c:f>'Cell number'!$D$60</c:f>
              <c:strCache>
                <c:ptCount val="1"/>
                <c:pt idx="0">
                  <c:v>WT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Cell number'!$P$63:$T$63</c:f>
                <c:numCache>
                  <c:formatCode>General</c:formatCode>
                  <c:ptCount val="5"/>
                  <c:pt idx="0">
                    <c:v>4.6866216151044575E-2</c:v>
                  </c:pt>
                  <c:pt idx="1">
                    <c:v>5.0297532965595394E-2</c:v>
                  </c:pt>
                  <c:pt idx="2">
                    <c:v>0.11099212923634237</c:v>
                  </c:pt>
                  <c:pt idx="3">
                    <c:v>0.12764702436474737</c:v>
                  </c:pt>
                  <c:pt idx="4">
                    <c:v>0.21106925821079034</c:v>
                  </c:pt>
                </c:numCache>
              </c:numRef>
            </c:plus>
            <c:minus>
              <c:numRef>
                <c:f>'Cell number'!$P$63:$T$63</c:f>
                <c:numCache>
                  <c:formatCode>General</c:formatCode>
                  <c:ptCount val="5"/>
                  <c:pt idx="0">
                    <c:v>4.6866216151044575E-2</c:v>
                  </c:pt>
                  <c:pt idx="1">
                    <c:v>5.0297532965595394E-2</c:v>
                  </c:pt>
                  <c:pt idx="2">
                    <c:v>0.11099212923634237</c:v>
                  </c:pt>
                  <c:pt idx="3">
                    <c:v>0.12764702436474737</c:v>
                  </c:pt>
                  <c:pt idx="4">
                    <c:v>0.211069258210790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Cell number'!$P$59:$S$59</c:f>
              <c:numCache>
                <c:formatCode>0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xVal>
          <c:yVal>
            <c:numRef>
              <c:f>'Cell number'!$P$60:$S$60</c:f>
              <c:numCache>
                <c:formatCode>0.00</c:formatCode>
                <c:ptCount val="4"/>
                <c:pt idx="0">
                  <c:v>0.19082648000000005</c:v>
                </c:pt>
                <c:pt idx="1">
                  <c:v>0.21398191666666669</c:v>
                </c:pt>
                <c:pt idx="2">
                  <c:v>0.42198106666666685</c:v>
                </c:pt>
                <c:pt idx="3">
                  <c:v>0.8611450833333335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9FFD-4AC2-9568-89A7A679B9A9}"/>
            </c:ext>
          </c:extLst>
        </c:ser>
        <c:ser>
          <c:idx val="1"/>
          <c:order val="1"/>
          <c:tx>
            <c:strRef>
              <c:f>'Cell number'!$D$61</c:f>
              <c:strCache>
                <c:ptCount val="1"/>
                <c:pt idx="0">
                  <c:v>mutant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>
                  <a:lumMod val="85000"/>
                  <a:lumOff val="1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Cell number'!$P$64:$T$64</c:f>
                <c:numCache>
                  <c:formatCode>General</c:formatCode>
                  <c:ptCount val="5"/>
                  <c:pt idx="0">
                    <c:v>9.3784941901036544E-3</c:v>
                  </c:pt>
                  <c:pt idx="1">
                    <c:v>1.0193829325346097E-2</c:v>
                  </c:pt>
                  <c:pt idx="2">
                    <c:v>3.5812874969764624E-2</c:v>
                  </c:pt>
                  <c:pt idx="3">
                    <c:v>0.10382044021555803</c:v>
                  </c:pt>
                  <c:pt idx="4">
                    <c:v>0.14963162199760541</c:v>
                  </c:pt>
                </c:numCache>
              </c:numRef>
            </c:plus>
            <c:minus>
              <c:numRef>
                <c:f>'Cell number'!$P$64:$T$64</c:f>
                <c:numCache>
                  <c:formatCode>General</c:formatCode>
                  <c:ptCount val="5"/>
                  <c:pt idx="0">
                    <c:v>9.3784941901036544E-3</c:v>
                  </c:pt>
                  <c:pt idx="1">
                    <c:v>1.0193829325346097E-2</c:v>
                  </c:pt>
                  <c:pt idx="2">
                    <c:v>3.5812874969764624E-2</c:v>
                  </c:pt>
                  <c:pt idx="3">
                    <c:v>0.10382044021555803</c:v>
                  </c:pt>
                  <c:pt idx="4">
                    <c:v>0.149631621997605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Cell number'!$P$59:$S$59</c:f>
              <c:numCache>
                <c:formatCode>0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xVal>
          <c:yVal>
            <c:numRef>
              <c:f>'Cell number'!$P$61:$S$61</c:f>
              <c:numCache>
                <c:formatCode>0.00</c:formatCode>
                <c:ptCount val="4"/>
                <c:pt idx="0">
                  <c:v>5.094916666666667E-2</c:v>
                </c:pt>
                <c:pt idx="1">
                  <c:v>6.1410199999999998E-2</c:v>
                </c:pt>
                <c:pt idx="2">
                  <c:v>0.14357020000000004</c:v>
                </c:pt>
                <c:pt idx="3">
                  <c:v>0.5264231333333333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9FFD-4AC2-9568-89A7A679B9A9}"/>
            </c:ext>
          </c:extLst>
        </c:ser>
        <c:dLbls/>
        <c:axId val="106513536"/>
        <c:axId val="106515456"/>
      </c:scatterChart>
      <c:valAx>
        <c:axId val="106513536"/>
        <c:scaling>
          <c:orientation val="minMax"/>
          <c:max val="3.1"/>
          <c:min val="0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  <a:endParaRPr lang="en-GB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47898872894958511"/>
              <c:y val="0.90061606057515531"/>
            </c:manualLayout>
          </c:layout>
          <c:spPr>
            <a:noFill/>
            <a:ln>
              <a:noFill/>
            </a:ln>
            <a:effectLst/>
          </c:spPr>
        </c:title>
        <c:numFmt formatCode="0" sourceLinked="1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515456"/>
        <c:crosses val="autoZero"/>
        <c:crossBetween val="midCat"/>
        <c:majorUnit val="1"/>
      </c:valAx>
      <c:valAx>
        <c:axId val="106515456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 of CD8+</a:t>
                </a:r>
                <a:r>
                  <a:rPr lang="en-GB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s (</a:t>
                </a:r>
                <a:r>
                  <a:rPr lang="en-GB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x10</a:t>
                </a:r>
                <a:r>
                  <a:rPr lang="en-GB" sz="800" baseline="300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r>
                  <a:rPr lang="en-GB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GB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4.7622335902515099E-2"/>
              <c:y val="0.23393542803116965"/>
            </c:manualLayout>
          </c:layout>
          <c:spPr>
            <a:noFill/>
            <a:ln>
              <a:noFill/>
            </a:ln>
            <a:effectLst/>
          </c:spPr>
        </c:title>
        <c:numFmt formatCode="#,##0.0" sourceLinked="0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51353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>
        <c:manualLayout>
          <c:layoutTarget val="inner"/>
          <c:xMode val="edge"/>
          <c:yMode val="edge"/>
          <c:x val="0.22439772698315619"/>
          <c:y val="0.26404200777483799"/>
          <c:w val="0.65125189589861343"/>
          <c:h val="0.5859423665322997"/>
        </c:manualLayout>
      </c:layout>
      <c:barChart>
        <c:barDir val="col"/>
        <c:grouping val="clustered"/>
        <c:ser>
          <c:idx val="0"/>
          <c:order val="0"/>
          <c:tx>
            <c:strRef>
              <c:f>'Cell number'!$O$9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'Cell number'!$P$95:$T$95</c:f>
                <c:numCache>
                  <c:formatCode>General</c:formatCode>
                  <c:ptCount val="5"/>
                  <c:pt idx="0">
                    <c:v>0.6600959526210316</c:v>
                  </c:pt>
                  <c:pt idx="1">
                    <c:v>0.89439098726185629</c:v>
                  </c:pt>
                  <c:pt idx="2">
                    <c:v>1.9927062240175326</c:v>
                  </c:pt>
                  <c:pt idx="3">
                    <c:v>3.6272647441025621</c:v>
                  </c:pt>
                  <c:pt idx="4">
                    <c:v>5.2124938734689898</c:v>
                  </c:pt>
                </c:numCache>
              </c:numRef>
            </c:plus>
            <c:minus>
              <c:numRef>
                <c:f>'Cell number'!$P$95:$T$95</c:f>
                <c:numCache>
                  <c:formatCode>General</c:formatCode>
                  <c:ptCount val="5"/>
                  <c:pt idx="0">
                    <c:v>0.6600959526210316</c:v>
                  </c:pt>
                  <c:pt idx="1">
                    <c:v>0.89439098726185629</c:v>
                  </c:pt>
                  <c:pt idx="2">
                    <c:v>1.9927062240175326</c:v>
                  </c:pt>
                  <c:pt idx="3">
                    <c:v>3.6272647441025621</c:v>
                  </c:pt>
                  <c:pt idx="4">
                    <c:v>5.21249387346898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Cell number'!$P$91:$S$91</c:f>
              <c:numCache>
                <c:formatCode>0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'Cell number'!$P$92:$S$92</c:f>
              <c:numCache>
                <c:formatCode>0.00</c:formatCode>
                <c:ptCount val="4"/>
                <c:pt idx="0">
                  <c:v>9.2013333333333307</c:v>
                </c:pt>
                <c:pt idx="1">
                  <c:v>12.920666666666671</c:v>
                </c:pt>
                <c:pt idx="2">
                  <c:v>18.922666666666661</c:v>
                </c:pt>
                <c:pt idx="3">
                  <c:v>34.6473333333333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5E9-412F-A323-50CEF057FAB3}"/>
            </c:ext>
          </c:extLst>
        </c:ser>
        <c:ser>
          <c:idx val="1"/>
          <c:order val="1"/>
          <c:tx>
            <c:strRef>
              <c:f>'Cell number'!$O$93</c:f>
              <c:strCache>
                <c:ptCount val="1"/>
                <c:pt idx="0">
                  <c:v>mutant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12700"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'Cell number'!$P$96:$T$96</c:f>
                <c:numCache>
                  <c:formatCode>General</c:formatCode>
                  <c:ptCount val="5"/>
                  <c:pt idx="0">
                    <c:v>0.30443546505121977</c:v>
                  </c:pt>
                  <c:pt idx="1">
                    <c:v>0.64430102399717626</c:v>
                  </c:pt>
                  <c:pt idx="2">
                    <c:v>1.3290340208480111</c:v>
                  </c:pt>
                  <c:pt idx="3">
                    <c:v>3.2467962230922098</c:v>
                  </c:pt>
                  <c:pt idx="4">
                    <c:v>8.2169474693639284</c:v>
                  </c:pt>
                </c:numCache>
              </c:numRef>
            </c:plus>
            <c:minus>
              <c:numRef>
                <c:f>'Cell number'!$P$96:$T$96</c:f>
                <c:numCache>
                  <c:formatCode>General</c:formatCode>
                  <c:ptCount val="5"/>
                  <c:pt idx="0">
                    <c:v>0.30443546505121977</c:v>
                  </c:pt>
                  <c:pt idx="1">
                    <c:v>0.64430102399717626</c:v>
                  </c:pt>
                  <c:pt idx="2">
                    <c:v>1.3290340208480111</c:v>
                  </c:pt>
                  <c:pt idx="3">
                    <c:v>3.2467962230922098</c:v>
                  </c:pt>
                  <c:pt idx="4">
                    <c:v>8.21694746936392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Cell number'!$P$91:$S$91</c:f>
              <c:numCache>
                <c:formatCode>0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'Cell number'!$P$93:$S$93</c:f>
              <c:numCache>
                <c:formatCode>0.00</c:formatCode>
                <c:ptCount val="4"/>
                <c:pt idx="0">
                  <c:v>2.6366666666666663</c:v>
                </c:pt>
                <c:pt idx="1">
                  <c:v>4.3566666666666674</c:v>
                </c:pt>
                <c:pt idx="2">
                  <c:v>10.338000000000001</c:v>
                </c:pt>
                <c:pt idx="3">
                  <c:v>25.88999999999999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5E9-412F-A323-50CEF057FAB3}"/>
            </c:ext>
          </c:extLst>
        </c:ser>
        <c:dLbls/>
        <c:axId val="106444288"/>
        <c:axId val="106446208"/>
      </c:barChart>
      <c:catAx>
        <c:axId val="106444288"/>
        <c:scaling>
          <c:orientation val="minMax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  <a:endParaRPr lang="en-GB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0" sourceLinked="1"/>
        <c:majorTickMark val="none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446208"/>
        <c:crosses val="autoZero"/>
        <c:auto val="1"/>
        <c:lblAlgn val="ctr"/>
        <c:lblOffset val="100"/>
        <c:tickMarkSkip val="1"/>
      </c:catAx>
      <c:valAx>
        <c:axId val="106446208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r>
                  <a:rPr lang="en-GB" sz="800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of </a:t>
                </a:r>
                <a:r>
                  <a:rPr lang="en-GB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8+ cells</a:t>
                </a:r>
              </a:p>
            </c:rich>
          </c:tx>
          <c:layout>
            <c:manualLayout>
              <c:xMode val="edge"/>
              <c:yMode val="edge"/>
              <c:x val="6.9948924876759161E-2"/>
              <c:y val="0.34515624637072168"/>
            </c:manualLayout>
          </c:layout>
          <c:spPr>
            <a:noFill/>
            <a:ln>
              <a:noFill/>
            </a:ln>
            <a:effectLst/>
          </c:spPr>
        </c:title>
        <c:numFmt formatCode="#,##0" sourceLinked="0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444288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>
        <c:manualLayout>
          <c:layoutTarget val="inner"/>
          <c:xMode val="edge"/>
          <c:yMode val="edge"/>
          <c:x val="0.22439772698315619"/>
          <c:y val="0.21980318489645176"/>
          <c:w val="0.69363566415689781"/>
          <c:h val="0.63018096673888391"/>
        </c:manualLayout>
      </c:layout>
      <c:scatterChart>
        <c:scatterStyle val="smoothMarker"/>
        <c:ser>
          <c:idx val="0"/>
          <c:order val="0"/>
          <c:tx>
            <c:strRef>
              <c:f>'Cell number'!$D$60</c:f>
              <c:strCache>
                <c:ptCount val="1"/>
                <c:pt idx="0">
                  <c:v>WT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Cell number'!$E$63:$I$63</c:f>
                <c:numCache>
                  <c:formatCode>General</c:formatCode>
                  <c:ptCount val="5"/>
                  <c:pt idx="0">
                    <c:v>8.4076282323444135E-2</c:v>
                  </c:pt>
                  <c:pt idx="1">
                    <c:v>6.3166087350333869E-2</c:v>
                  </c:pt>
                  <c:pt idx="2">
                    <c:v>8.8143758781262058E-2</c:v>
                  </c:pt>
                  <c:pt idx="3">
                    <c:v>9.4885873500299103E-2</c:v>
                  </c:pt>
                  <c:pt idx="4">
                    <c:v>5.3699887978130981E-2</c:v>
                  </c:pt>
                </c:numCache>
              </c:numRef>
            </c:plus>
            <c:minus>
              <c:numRef>
                <c:f>'Cell number'!$E$63:$I$63</c:f>
                <c:numCache>
                  <c:formatCode>General</c:formatCode>
                  <c:ptCount val="5"/>
                  <c:pt idx="0">
                    <c:v>8.4076282323444135E-2</c:v>
                  </c:pt>
                  <c:pt idx="1">
                    <c:v>6.3166087350333869E-2</c:v>
                  </c:pt>
                  <c:pt idx="2">
                    <c:v>8.8143758781262058E-2</c:v>
                  </c:pt>
                  <c:pt idx="3">
                    <c:v>9.4885873500299103E-2</c:v>
                  </c:pt>
                  <c:pt idx="4">
                    <c:v>5.369988797813098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Cell number'!$E$59:$H$59</c:f>
              <c:numCache>
                <c:formatCode>0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xVal>
          <c:yVal>
            <c:numRef>
              <c:f>'Cell number'!$E$60:$H$60</c:f>
              <c:numCache>
                <c:formatCode>0.00</c:formatCode>
                <c:ptCount val="4"/>
                <c:pt idx="0">
                  <c:v>0.3403076608333333</c:v>
                </c:pt>
                <c:pt idx="1">
                  <c:v>0.24540805000000002</c:v>
                </c:pt>
                <c:pt idx="2">
                  <c:v>0.42172852500000008</c:v>
                </c:pt>
                <c:pt idx="3">
                  <c:v>0.3497821250000000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DDD4-491D-82F0-83CE253F53C0}"/>
            </c:ext>
          </c:extLst>
        </c:ser>
        <c:ser>
          <c:idx val="1"/>
          <c:order val="1"/>
          <c:tx>
            <c:strRef>
              <c:f>'Cell number'!$D$61</c:f>
              <c:strCache>
                <c:ptCount val="1"/>
                <c:pt idx="0">
                  <c:v>mutant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>
                  <a:lumMod val="85000"/>
                  <a:lumOff val="1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plus>
              <c:numRef>
                <c:f>'Cell number'!$E$64:$I$64</c:f>
                <c:numCache>
                  <c:formatCode>General</c:formatCode>
                  <c:ptCount val="5"/>
                  <c:pt idx="0">
                    <c:v>2.8408146967903485E-2</c:v>
                  </c:pt>
                  <c:pt idx="1">
                    <c:v>1.8899997792390873E-2</c:v>
                  </c:pt>
                  <c:pt idx="2">
                    <c:v>3.9050353345514391E-2</c:v>
                  </c:pt>
                  <c:pt idx="3">
                    <c:v>6.3987827033927275E-2</c:v>
                  </c:pt>
                  <c:pt idx="4">
                    <c:v>2.3285971067054802E-2</c:v>
                  </c:pt>
                </c:numCache>
              </c:numRef>
            </c:plus>
            <c:minus>
              <c:numRef>
                <c:f>'Cell number'!$E$64:$I$64</c:f>
                <c:numCache>
                  <c:formatCode>General</c:formatCode>
                  <c:ptCount val="5"/>
                  <c:pt idx="0">
                    <c:v>2.8408146967903485E-2</c:v>
                  </c:pt>
                  <c:pt idx="1">
                    <c:v>1.8899997792390873E-2</c:v>
                  </c:pt>
                  <c:pt idx="2">
                    <c:v>3.9050353345514391E-2</c:v>
                  </c:pt>
                  <c:pt idx="3">
                    <c:v>6.3987827033927275E-2</c:v>
                  </c:pt>
                  <c:pt idx="4">
                    <c:v>2.32859710670548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Cell number'!$E$59:$H$59</c:f>
              <c:numCache>
                <c:formatCode>0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xVal>
          <c:yVal>
            <c:numRef>
              <c:f>'Cell number'!$E$61:$H$61</c:f>
              <c:numCache>
                <c:formatCode>0.00</c:formatCode>
                <c:ptCount val="4"/>
                <c:pt idx="0">
                  <c:v>0.11525609999999999</c:v>
                </c:pt>
                <c:pt idx="1">
                  <c:v>8.9770133333333349E-2</c:v>
                </c:pt>
                <c:pt idx="2">
                  <c:v>0.14434613333333338</c:v>
                </c:pt>
                <c:pt idx="3">
                  <c:v>0.2354763333333334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DDD4-491D-82F0-83CE253F53C0}"/>
            </c:ext>
          </c:extLst>
        </c:ser>
        <c:dLbls/>
        <c:axId val="106675200"/>
        <c:axId val="106718336"/>
      </c:scatterChart>
      <c:valAx>
        <c:axId val="106675200"/>
        <c:scaling>
          <c:orientation val="minMax"/>
          <c:max val="3.1"/>
          <c:min val="0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  <a:endParaRPr lang="en-GB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0" sourceLinked="1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718336"/>
        <c:crosses val="autoZero"/>
        <c:crossBetween val="midCat"/>
        <c:majorUnit val="1"/>
      </c:valAx>
      <c:valAx>
        <c:axId val="106718336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 of CD4+</a:t>
                </a:r>
                <a:r>
                  <a:rPr lang="en-GB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s (</a:t>
                </a:r>
                <a:r>
                  <a:rPr lang="en-GB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x10</a:t>
                </a:r>
                <a:r>
                  <a:rPr lang="en-GB" sz="800" baseline="300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r>
                  <a:rPr lang="en-GB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GB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5.1604946666884928E-2"/>
              <c:y val="0.23596983554192827"/>
            </c:manualLayout>
          </c:layout>
          <c:spPr>
            <a:noFill/>
            <a:ln>
              <a:noFill/>
            </a:ln>
            <a:effectLst/>
          </c:spPr>
        </c:title>
        <c:numFmt formatCode="#,##0.0" sourceLinked="0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6752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3A2D0E-77F8-4E14-B3B7-D27A7416DDC1}" type="datetimeFigureOut">
              <a:rPr lang="en-GB" smtClean="0"/>
              <a:pPr/>
              <a:t>22/11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41E9DA-B4A9-4BC7-BCDD-43E7E6E609F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808304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7003C-4DD2-47FC-A880-699F7C021B92}" type="datetimeFigureOut">
              <a:rPr lang="en-GB" smtClean="0"/>
              <a:pPr/>
              <a:t>22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09FC5-1533-4A91-9144-D088A7BC3EB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376927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7003C-4DD2-47FC-A880-699F7C021B92}" type="datetimeFigureOut">
              <a:rPr lang="en-GB" smtClean="0"/>
              <a:pPr/>
              <a:t>22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09FC5-1533-4A91-9144-D088A7BC3EB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337385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7003C-4DD2-47FC-A880-699F7C021B92}" type="datetimeFigureOut">
              <a:rPr lang="en-GB" smtClean="0"/>
              <a:pPr/>
              <a:t>22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09FC5-1533-4A91-9144-D088A7BC3EB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33116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7003C-4DD2-47FC-A880-699F7C021B92}" type="datetimeFigureOut">
              <a:rPr lang="en-GB" smtClean="0"/>
              <a:pPr/>
              <a:t>22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09FC5-1533-4A91-9144-D088A7BC3EB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754126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7003C-4DD2-47FC-A880-699F7C021B92}" type="datetimeFigureOut">
              <a:rPr lang="en-GB" smtClean="0"/>
              <a:pPr/>
              <a:t>22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09FC5-1533-4A91-9144-D088A7BC3EB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782483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7003C-4DD2-47FC-A880-699F7C021B92}" type="datetimeFigureOut">
              <a:rPr lang="en-GB" smtClean="0"/>
              <a:pPr/>
              <a:t>22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09FC5-1533-4A91-9144-D088A7BC3EB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894804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7003C-4DD2-47FC-A880-699F7C021B92}" type="datetimeFigureOut">
              <a:rPr lang="en-GB" smtClean="0"/>
              <a:pPr/>
              <a:t>22/11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09FC5-1533-4A91-9144-D088A7BC3EB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579336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7003C-4DD2-47FC-A880-699F7C021B92}" type="datetimeFigureOut">
              <a:rPr lang="en-GB" smtClean="0"/>
              <a:pPr/>
              <a:t>22/11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09FC5-1533-4A91-9144-D088A7BC3EB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92744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7003C-4DD2-47FC-A880-699F7C021B92}" type="datetimeFigureOut">
              <a:rPr lang="en-GB" smtClean="0"/>
              <a:pPr/>
              <a:t>22/11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09FC5-1533-4A91-9144-D088A7BC3EB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282337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7003C-4DD2-47FC-A880-699F7C021B92}" type="datetimeFigureOut">
              <a:rPr lang="en-GB" smtClean="0"/>
              <a:pPr/>
              <a:t>22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09FC5-1533-4A91-9144-D088A7BC3EB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3882186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7003C-4DD2-47FC-A880-699F7C021B92}" type="datetimeFigureOut">
              <a:rPr lang="en-GB" smtClean="0"/>
              <a:pPr/>
              <a:t>22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09FC5-1533-4A91-9144-D088A7BC3EB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12479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7003C-4DD2-47FC-A880-699F7C021B92}" type="datetimeFigureOut">
              <a:rPr lang="en-GB" smtClean="0"/>
              <a:pPr/>
              <a:t>22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09FC5-1533-4A91-9144-D088A7BC3EB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898367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5" name="Picture 144"/>
          <p:cNvPicPr>
            <a:picLocks noChangeAspect="1"/>
          </p:cNvPicPr>
          <p:nvPr/>
        </p:nvPicPr>
        <p:blipFill rotWithShape="1">
          <a:blip r:embed="rId2" cstate="print"/>
          <a:srcRect l="17577" t="6045" b="6264"/>
          <a:stretch/>
        </p:blipFill>
        <p:spPr>
          <a:xfrm>
            <a:off x="3807335" y="1840936"/>
            <a:ext cx="870344" cy="792092"/>
          </a:xfrm>
          <a:prstGeom prst="rect">
            <a:avLst/>
          </a:prstGeom>
        </p:spPr>
      </p:pic>
      <p:pic>
        <p:nvPicPr>
          <p:cNvPr id="147" name="Picture 146"/>
          <p:cNvPicPr>
            <a:picLocks noChangeAspect="1"/>
          </p:cNvPicPr>
          <p:nvPr/>
        </p:nvPicPr>
        <p:blipFill rotWithShape="1">
          <a:blip r:embed="rId3" cstate="print"/>
          <a:srcRect l="17759" t="5729" b="6163"/>
          <a:stretch/>
        </p:blipFill>
        <p:spPr>
          <a:xfrm>
            <a:off x="4830164" y="1834119"/>
            <a:ext cx="851119" cy="78918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119497" y="469133"/>
            <a:ext cx="18793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218865" y="3436758"/>
            <a:ext cx="2589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218865" y="2086192"/>
            <a:ext cx="3316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218865" y="756461"/>
            <a:ext cx="2589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3726" t="6293" b="5594"/>
          <a:stretch/>
        </p:blipFill>
        <p:spPr bwMode="auto">
          <a:xfrm>
            <a:off x="1612395" y="2331719"/>
            <a:ext cx="856997" cy="7846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7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4206" t="6993" b="5945"/>
          <a:stretch/>
        </p:blipFill>
        <p:spPr bwMode="auto">
          <a:xfrm>
            <a:off x="2645759" y="2331245"/>
            <a:ext cx="831489" cy="7851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1779914" y="3095052"/>
            <a:ext cx="6676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8-APC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1227727" y="2535772"/>
            <a:ext cx="6577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-P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913069" y="2157361"/>
            <a:ext cx="5499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843589" y="2157361"/>
            <a:ext cx="7739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utant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786822" y="3095052"/>
            <a:ext cx="10763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8-APC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2049356" y="2299489"/>
            <a:ext cx="10763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-P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4" name="Picture 3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56108" t="50503" r="1885" b="9313"/>
          <a:stretch/>
        </p:blipFill>
        <p:spPr bwMode="auto">
          <a:xfrm>
            <a:off x="2645759" y="1045421"/>
            <a:ext cx="831489" cy="8137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5" name="Picture 3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8485" t="50064" r="49508" b="9752"/>
          <a:stretch/>
        </p:blipFill>
        <p:spPr bwMode="auto">
          <a:xfrm>
            <a:off x="1612395" y="1031745"/>
            <a:ext cx="852481" cy="8342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6" name="TextBox 115"/>
          <p:cNvSpPr txBox="1"/>
          <p:nvPr/>
        </p:nvSpPr>
        <p:spPr>
          <a:xfrm>
            <a:off x="1759968" y="1815361"/>
            <a:ext cx="6676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8-FITC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 rot="16200000">
            <a:off x="1098789" y="1217111"/>
            <a:ext cx="884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-PECy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1887618" y="892664"/>
            <a:ext cx="5499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2818138" y="892664"/>
            <a:ext cx="7739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utant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2822979" y="1815361"/>
            <a:ext cx="6676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8-FITC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 rot="16200000">
            <a:off x="2129711" y="1217110"/>
            <a:ext cx="8846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-PECy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3512081" y="756461"/>
            <a:ext cx="3316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3872196" y="2608557"/>
            <a:ext cx="9544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25-PECy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 rot="16200000">
            <a:off x="3427583" y="2033038"/>
            <a:ext cx="6577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4-P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4966123" y="1521965"/>
            <a:ext cx="779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/8-FITC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4888707" y="2608557"/>
            <a:ext cx="9763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25-PECy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 rot="16200000">
            <a:off x="4444094" y="2033038"/>
            <a:ext cx="6577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4-P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4082171" y="941029"/>
            <a:ext cx="5499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5012691" y="941029"/>
            <a:ext cx="7739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utant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7" name="Straight Arrow Connector 156"/>
          <p:cNvCxnSpPr/>
          <p:nvPr/>
        </p:nvCxnSpPr>
        <p:spPr>
          <a:xfrm>
            <a:off x="3963587" y="1557546"/>
            <a:ext cx="0" cy="288000"/>
          </a:xfrm>
          <a:prstGeom prst="straightConnector1">
            <a:avLst/>
          </a:prstGeom>
          <a:ln>
            <a:headEnd type="none" w="med" len="med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9" name="Straight Arrow Connector 158"/>
          <p:cNvCxnSpPr/>
          <p:nvPr/>
        </p:nvCxnSpPr>
        <p:spPr>
          <a:xfrm flipH="1">
            <a:off x="4978975" y="1557546"/>
            <a:ext cx="0" cy="288000"/>
          </a:xfrm>
          <a:prstGeom prst="straightConnector1">
            <a:avLst/>
          </a:prstGeom>
          <a:ln>
            <a:headEnd type="none" w="med" len="med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66" name="Picture 165"/>
          <p:cNvPicPr>
            <a:picLocks noChangeAspect="1"/>
          </p:cNvPicPr>
          <p:nvPr/>
        </p:nvPicPr>
        <p:blipFill rotWithShape="1">
          <a:blip r:embed="rId8" cstate="print"/>
          <a:srcRect l="5044" t="10013" b="11475"/>
          <a:stretch/>
        </p:blipFill>
        <p:spPr>
          <a:xfrm>
            <a:off x="3745707" y="1115740"/>
            <a:ext cx="993600" cy="431570"/>
          </a:xfrm>
          <a:prstGeom prst="rect">
            <a:avLst/>
          </a:prstGeom>
        </p:spPr>
      </p:pic>
      <p:pic>
        <p:nvPicPr>
          <p:cNvPr id="168" name="Picture 167"/>
          <p:cNvPicPr>
            <a:picLocks noChangeAspect="1"/>
          </p:cNvPicPr>
          <p:nvPr/>
        </p:nvPicPr>
        <p:blipFill rotWithShape="1">
          <a:blip r:embed="rId9" cstate="print"/>
          <a:srcRect l="4775" t="11063" b="10596"/>
          <a:stretch/>
        </p:blipFill>
        <p:spPr>
          <a:xfrm>
            <a:off x="4772962" y="1127577"/>
            <a:ext cx="994907" cy="429969"/>
          </a:xfrm>
          <a:prstGeom prst="rect">
            <a:avLst/>
          </a:prstGeom>
        </p:spPr>
      </p:pic>
      <p:sp>
        <p:nvSpPr>
          <p:cNvPr id="169" name="TextBox 168"/>
          <p:cNvSpPr txBox="1"/>
          <p:nvPr/>
        </p:nvSpPr>
        <p:spPr>
          <a:xfrm>
            <a:off x="3948089" y="1505496"/>
            <a:ext cx="779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/8-FITC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2" name="Picture 2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1200" t="4460" b="6344"/>
          <a:stretch/>
        </p:blipFill>
        <p:spPr bwMode="auto">
          <a:xfrm>
            <a:off x="4840051" y="3886658"/>
            <a:ext cx="774521" cy="76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7" name="Picture 3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1615" t="4460" b="6344"/>
          <a:stretch/>
        </p:blipFill>
        <p:spPr bwMode="auto">
          <a:xfrm>
            <a:off x="3962773" y="3886658"/>
            <a:ext cx="770901" cy="76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8" name="Picture 4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1615" t="4460" b="6344"/>
          <a:stretch/>
        </p:blipFill>
        <p:spPr bwMode="auto">
          <a:xfrm>
            <a:off x="1694833" y="3885798"/>
            <a:ext cx="771770" cy="7628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" name="Picture 5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1312" t="4460" b="6344"/>
          <a:stretch/>
        </p:blipFill>
        <p:spPr bwMode="auto">
          <a:xfrm>
            <a:off x="2604928" y="3885799"/>
            <a:ext cx="774417" cy="7628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" name="Picture 7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1615" t="5459" b="6489"/>
          <a:stretch/>
        </p:blipFill>
        <p:spPr bwMode="auto">
          <a:xfrm>
            <a:off x="1695857" y="4751352"/>
            <a:ext cx="770746" cy="752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" name="Picture 10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0864" t="5459" b="6258"/>
          <a:stretch/>
        </p:blipFill>
        <p:spPr bwMode="auto">
          <a:xfrm>
            <a:off x="2602049" y="4751352"/>
            <a:ext cx="777296" cy="7540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" name="Picture 12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1424" t="6344" b="6176"/>
          <a:stretch/>
        </p:blipFill>
        <p:spPr bwMode="auto">
          <a:xfrm>
            <a:off x="4842004" y="5632536"/>
            <a:ext cx="772568" cy="7473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" name="Picture 13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1615" t="6345" b="6404"/>
          <a:stretch/>
        </p:blipFill>
        <p:spPr bwMode="auto">
          <a:xfrm>
            <a:off x="3962774" y="5632536"/>
            <a:ext cx="770900" cy="7453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4" name="Picture 14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1615" t="5459" b="6258"/>
          <a:stretch/>
        </p:blipFill>
        <p:spPr bwMode="auto">
          <a:xfrm>
            <a:off x="3962774" y="4751352"/>
            <a:ext cx="770900" cy="7541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5" name="Picture 15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0976" t="5459" b="6258"/>
          <a:stretch/>
        </p:blipFill>
        <p:spPr bwMode="auto">
          <a:xfrm>
            <a:off x="4838097" y="4751352"/>
            <a:ext cx="776475" cy="7541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6" name="Picture 7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5436" t="7008" b="6197"/>
          <a:stretch/>
        </p:blipFill>
        <p:spPr bwMode="auto">
          <a:xfrm>
            <a:off x="1685517" y="5632536"/>
            <a:ext cx="781086" cy="7557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7" name="Picture 9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5597" t="6944" b="6260"/>
          <a:stretch/>
        </p:blipFill>
        <p:spPr bwMode="auto">
          <a:xfrm>
            <a:off x="2600213" y="5632536"/>
            <a:ext cx="779132" cy="7557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8" name="TextBox 87"/>
          <p:cNvSpPr txBox="1"/>
          <p:nvPr/>
        </p:nvSpPr>
        <p:spPr>
          <a:xfrm>
            <a:off x="1905866" y="3749828"/>
            <a:ext cx="3706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2741840" y="3746543"/>
            <a:ext cx="881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utant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 rot="16200000">
            <a:off x="3138058" y="4194166"/>
            <a:ext cx="6132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 hours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Connector 90"/>
          <p:cNvCxnSpPr/>
          <p:nvPr/>
        </p:nvCxnSpPr>
        <p:spPr bwMode="auto">
          <a:xfrm>
            <a:off x="1757743" y="6447299"/>
            <a:ext cx="1548000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92" name="TextBox 91"/>
          <p:cNvSpPr txBox="1"/>
          <p:nvPr/>
        </p:nvSpPr>
        <p:spPr>
          <a:xfrm>
            <a:off x="2210761" y="6460058"/>
            <a:ext cx="13347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25-PECy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Straight Connector 92"/>
          <p:cNvCxnSpPr/>
          <p:nvPr/>
        </p:nvCxnSpPr>
        <p:spPr bwMode="auto">
          <a:xfrm flipV="1">
            <a:off x="1563161" y="3965272"/>
            <a:ext cx="0" cy="228600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94" name="TextBox 93"/>
          <p:cNvSpPr txBox="1"/>
          <p:nvPr/>
        </p:nvSpPr>
        <p:spPr>
          <a:xfrm rot="16200000">
            <a:off x="1030667" y="4822001"/>
            <a:ext cx="8887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69-FITC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 rot="16200000">
            <a:off x="3099614" y="4961677"/>
            <a:ext cx="6900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 hours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4187621" y="3745615"/>
            <a:ext cx="3706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4984517" y="3742330"/>
            <a:ext cx="881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utant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 rot="16200000">
            <a:off x="5365237" y="4189953"/>
            <a:ext cx="6132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 hours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Straight Connector 103"/>
          <p:cNvCxnSpPr/>
          <p:nvPr/>
        </p:nvCxnSpPr>
        <p:spPr bwMode="auto">
          <a:xfrm>
            <a:off x="4000420" y="6447299"/>
            <a:ext cx="1548000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07" name="TextBox 106"/>
          <p:cNvSpPr txBox="1"/>
          <p:nvPr/>
        </p:nvSpPr>
        <p:spPr>
          <a:xfrm>
            <a:off x="4453438" y="6460058"/>
            <a:ext cx="13347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25-PECy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 rot="16200000">
            <a:off x="5326793" y="4957464"/>
            <a:ext cx="6900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 hours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Straight Connector 108"/>
          <p:cNvCxnSpPr/>
          <p:nvPr/>
        </p:nvCxnSpPr>
        <p:spPr>
          <a:xfrm>
            <a:off x="1573530" y="3679595"/>
            <a:ext cx="1747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>
            <a:off x="3886457" y="3679595"/>
            <a:ext cx="1747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1985779" y="3465398"/>
            <a:ext cx="12250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D4+ splenocyte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4239502" y="3465398"/>
            <a:ext cx="12250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D8+ splenocyte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 rot="16200000">
            <a:off x="3075427" y="5847227"/>
            <a:ext cx="830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 hours - no stimulation 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 rot="16200000">
            <a:off x="5259536" y="5850653"/>
            <a:ext cx="94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 hours - no stimulation 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Straight Connector 118"/>
          <p:cNvCxnSpPr/>
          <p:nvPr/>
        </p:nvCxnSpPr>
        <p:spPr bwMode="auto">
          <a:xfrm flipV="1">
            <a:off x="3838389" y="3948968"/>
            <a:ext cx="0" cy="228600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20" name="TextBox 119"/>
          <p:cNvSpPr txBox="1"/>
          <p:nvPr/>
        </p:nvSpPr>
        <p:spPr>
          <a:xfrm rot="16200000">
            <a:off x="3305895" y="4805697"/>
            <a:ext cx="8887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69-FITC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2"/>
          <p:cNvSpPr/>
          <p:nvPr/>
        </p:nvSpPr>
        <p:spPr>
          <a:xfrm>
            <a:off x="1266566" y="792652"/>
            <a:ext cx="4644000" cy="596649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" name="TextBox 73"/>
          <p:cNvSpPr txBox="1"/>
          <p:nvPr/>
        </p:nvSpPr>
        <p:spPr>
          <a:xfrm>
            <a:off x="3512081" y="3436758"/>
            <a:ext cx="2589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4567551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1" name="Chart 6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556035276"/>
              </p:ext>
            </p:extLst>
          </p:nvPr>
        </p:nvGraphicFramePr>
        <p:xfrm>
          <a:off x="1159759" y="2477715"/>
          <a:ext cx="2404769" cy="17856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0" name="TextBox 39"/>
          <p:cNvSpPr txBox="1"/>
          <p:nvPr/>
        </p:nvSpPr>
        <p:spPr>
          <a:xfrm>
            <a:off x="4058690" y="519139"/>
            <a:ext cx="1849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166960" y="2514712"/>
            <a:ext cx="2589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23853" y="4201266"/>
            <a:ext cx="2589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341750" y="790645"/>
            <a:ext cx="3316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154604" y="790645"/>
            <a:ext cx="2589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106447025"/>
              </p:ext>
            </p:extLst>
          </p:nvPr>
        </p:nvGraphicFramePr>
        <p:xfrm>
          <a:off x="3435179" y="962903"/>
          <a:ext cx="2142010" cy="14828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29" name="Group 28"/>
          <p:cNvGrpSpPr/>
          <p:nvPr/>
        </p:nvGrpSpPr>
        <p:grpSpPr>
          <a:xfrm>
            <a:off x="2147580" y="937864"/>
            <a:ext cx="801767" cy="215876"/>
            <a:chOff x="5410111" y="749095"/>
            <a:chExt cx="801767" cy="215876"/>
          </a:xfrm>
        </p:grpSpPr>
        <p:sp>
          <p:nvSpPr>
            <p:cNvPr id="35" name="Rectangle 34"/>
            <p:cNvSpPr/>
            <p:nvPr/>
          </p:nvSpPr>
          <p:spPr>
            <a:xfrm>
              <a:off x="5410111" y="838962"/>
              <a:ext cx="54000" cy="54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410111" y="749527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5711420" y="836070"/>
              <a:ext cx="54000" cy="5400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711420" y="749095"/>
              <a:ext cx="5004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tant</a:t>
              </a:r>
              <a:endParaRPr lang="en-GB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" name="Group 38"/>
          <p:cNvGrpSpPr/>
          <p:nvPr/>
        </p:nvGrpSpPr>
        <p:grpSpPr>
          <a:xfrm>
            <a:off x="4244154" y="929395"/>
            <a:ext cx="801767" cy="215876"/>
            <a:chOff x="5410111" y="749095"/>
            <a:chExt cx="801767" cy="215876"/>
          </a:xfrm>
        </p:grpSpPr>
        <p:sp>
          <p:nvSpPr>
            <p:cNvPr id="41" name="Rectangle 40"/>
            <p:cNvSpPr/>
            <p:nvPr/>
          </p:nvSpPr>
          <p:spPr>
            <a:xfrm>
              <a:off x="5410111" y="838962"/>
              <a:ext cx="54000" cy="54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410111" y="749527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ectangle 42"/>
            <p:cNvSpPr/>
            <p:nvPr/>
          </p:nvSpPr>
          <p:spPr>
            <a:xfrm>
              <a:off x="5711420" y="836070"/>
              <a:ext cx="54000" cy="5400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711420" y="749095"/>
              <a:ext cx="5004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tant</a:t>
              </a:r>
              <a:endParaRPr lang="en-GB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1834181" y="3496917"/>
            <a:ext cx="3622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231929" y="3457662"/>
            <a:ext cx="3809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5" name="Group 44"/>
          <p:cNvGrpSpPr/>
          <p:nvPr/>
        </p:nvGrpSpPr>
        <p:grpSpPr>
          <a:xfrm>
            <a:off x="2051369" y="2740379"/>
            <a:ext cx="969514" cy="257685"/>
            <a:chOff x="5410111" y="765018"/>
            <a:chExt cx="801767" cy="218474"/>
          </a:xfrm>
        </p:grpSpPr>
        <p:sp>
          <p:nvSpPr>
            <p:cNvPr id="49" name="TextBox 48"/>
            <p:cNvSpPr txBox="1"/>
            <p:nvPr/>
          </p:nvSpPr>
          <p:spPr>
            <a:xfrm>
              <a:off x="5711420" y="765018"/>
              <a:ext cx="5004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tant</a:t>
              </a:r>
              <a:endParaRPr lang="en-GB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Rectangle 45"/>
            <p:cNvSpPr/>
            <p:nvPr/>
          </p:nvSpPr>
          <p:spPr>
            <a:xfrm>
              <a:off x="5410111" y="838962"/>
              <a:ext cx="54000" cy="54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410111" y="768048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ectangle 47"/>
            <p:cNvSpPr/>
            <p:nvPr/>
          </p:nvSpPr>
          <p:spPr>
            <a:xfrm>
              <a:off x="5711420" y="839234"/>
              <a:ext cx="54000" cy="5400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55" name="Chart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4192655114"/>
              </p:ext>
            </p:extLst>
          </p:nvPr>
        </p:nvGraphicFramePr>
        <p:xfrm>
          <a:off x="1255210" y="928102"/>
          <a:ext cx="2155255" cy="14814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6" name="Rectangle 55"/>
          <p:cNvSpPr/>
          <p:nvPr/>
        </p:nvSpPr>
        <p:spPr>
          <a:xfrm>
            <a:off x="1192426" y="792653"/>
            <a:ext cx="4644000" cy="525776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TextBox 57"/>
          <p:cNvSpPr txBox="1"/>
          <p:nvPr/>
        </p:nvSpPr>
        <p:spPr>
          <a:xfrm>
            <a:off x="3498863" y="4245585"/>
            <a:ext cx="2589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0" name="Chart 5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144996570"/>
              </p:ext>
            </p:extLst>
          </p:nvPr>
        </p:nvGraphicFramePr>
        <p:xfrm>
          <a:off x="3354519" y="4247259"/>
          <a:ext cx="2490806" cy="1813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3" name="TextBox 62"/>
          <p:cNvSpPr txBox="1"/>
          <p:nvPr/>
        </p:nvSpPr>
        <p:spPr>
          <a:xfrm>
            <a:off x="2653395" y="3266030"/>
            <a:ext cx="3809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3291995" y="2354038"/>
            <a:ext cx="2529803" cy="1894316"/>
            <a:chOff x="1121752" y="4134757"/>
            <a:chExt cx="2529803" cy="1894316"/>
          </a:xfrm>
        </p:grpSpPr>
        <p:graphicFrame>
          <p:nvGraphicFramePr>
            <p:cNvPr id="62" name="Chart 6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2156928583"/>
                </p:ext>
              </p:extLst>
            </p:nvPr>
          </p:nvGraphicFramePr>
          <p:xfrm>
            <a:off x="1121752" y="4134757"/>
            <a:ext cx="2529803" cy="18943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26" name="TextBox 25"/>
            <p:cNvSpPr txBox="1"/>
            <p:nvPr/>
          </p:nvSpPr>
          <p:spPr>
            <a:xfrm>
              <a:off x="1820577" y="5514775"/>
              <a:ext cx="3924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0" name="Group 49"/>
            <p:cNvGrpSpPr/>
            <p:nvPr/>
          </p:nvGrpSpPr>
          <p:grpSpPr>
            <a:xfrm>
              <a:off x="1996005" y="4518567"/>
              <a:ext cx="969515" cy="264350"/>
              <a:chOff x="5410111" y="765591"/>
              <a:chExt cx="801767" cy="224124"/>
            </a:xfrm>
          </p:grpSpPr>
          <p:sp>
            <p:nvSpPr>
              <p:cNvPr id="51" name="Rectangle 50"/>
              <p:cNvSpPr/>
              <p:nvPr/>
            </p:nvSpPr>
            <p:spPr>
              <a:xfrm>
                <a:off x="5410111" y="838962"/>
                <a:ext cx="54000" cy="54000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5410111" y="774271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5711420" y="836070"/>
                <a:ext cx="54000" cy="54000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5711420" y="765591"/>
                <a:ext cx="5004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utant</a:t>
                </a:r>
                <a:endParaRPr lang="en-GB" sz="8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4" name="TextBox 63"/>
            <p:cNvSpPr txBox="1"/>
            <p:nvPr/>
          </p:nvSpPr>
          <p:spPr>
            <a:xfrm>
              <a:off x="2650972" y="5309583"/>
              <a:ext cx="3924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059393" y="4943405"/>
              <a:ext cx="3924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2243566" y="5454439"/>
              <a:ext cx="3924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1" name="Group 80"/>
          <p:cNvGrpSpPr/>
          <p:nvPr/>
        </p:nvGrpSpPr>
        <p:grpSpPr>
          <a:xfrm>
            <a:off x="4348763" y="4518060"/>
            <a:ext cx="969514" cy="257685"/>
            <a:chOff x="5410111" y="765018"/>
            <a:chExt cx="801767" cy="218474"/>
          </a:xfrm>
        </p:grpSpPr>
        <p:sp>
          <p:nvSpPr>
            <p:cNvPr id="82" name="TextBox 81"/>
            <p:cNvSpPr txBox="1"/>
            <p:nvPr/>
          </p:nvSpPr>
          <p:spPr>
            <a:xfrm>
              <a:off x="5711420" y="765018"/>
              <a:ext cx="5004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tant</a:t>
              </a:r>
              <a:endParaRPr lang="en-GB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Rectangle 82"/>
            <p:cNvSpPr/>
            <p:nvPr/>
          </p:nvSpPr>
          <p:spPr>
            <a:xfrm>
              <a:off x="5410111" y="838962"/>
              <a:ext cx="54000" cy="54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5410111" y="768048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Rectangle 84"/>
            <p:cNvSpPr/>
            <p:nvPr/>
          </p:nvSpPr>
          <p:spPr>
            <a:xfrm>
              <a:off x="5711420" y="839234"/>
              <a:ext cx="54000" cy="5400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7" name="TextBox 56"/>
          <p:cNvSpPr txBox="1"/>
          <p:nvPr/>
        </p:nvSpPr>
        <p:spPr>
          <a:xfrm>
            <a:off x="3370723" y="2468204"/>
            <a:ext cx="2589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1222064" y="4269440"/>
            <a:ext cx="2382291" cy="1760434"/>
            <a:chOff x="3360433" y="2468899"/>
            <a:chExt cx="2382291" cy="1760434"/>
          </a:xfrm>
        </p:grpSpPr>
        <p:graphicFrame>
          <p:nvGraphicFramePr>
            <p:cNvPr id="59" name="Chart 5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159127513"/>
                </p:ext>
              </p:extLst>
            </p:nvPr>
          </p:nvGraphicFramePr>
          <p:xfrm>
            <a:off x="3360433" y="2468899"/>
            <a:ext cx="2382291" cy="17604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pSp>
          <p:nvGrpSpPr>
            <p:cNvPr id="76" name="Group 75"/>
            <p:cNvGrpSpPr/>
            <p:nvPr/>
          </p:nvGrpSpPr>
          <p:grpSpPr>
            <a:xfrm>
              <a:off x="4331622" y="2731154"/>
              <a:ext cx="969514" cy="257685"/>
              <a:chOff x="5410111" y="765018"/>
              <a:chExt cx="801767" cy="218474"/>
            </a:xfrm>
          </p:grpSpPr>
          <p:sp>
            <p:nvSpPr>
              <p:cNvPr id="77" name="TextBox 76"/>
              <p:cNvSpPr txBox="1"/>
              <p:nvPr/>
            </p:nvSpPr>
            <p:spPr>
              <a:xfrm>
                <a:off x="5711420" y="765018"/>
                <a:ext cx="5004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utant</a:t>
                </a:r>
                <a:endParaRPr lang="en-GB" sz="8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Rectangle 77"/>
              <p:cNvSpPr/>
              <p:nvPr/>
            </p:nvSpPr>
            <p:spPr>
              <a:xfrm>
                <a:off x="5410111" y="838962"/>
                <a:ext cx="54000" cy="54000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5410111" y="768048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Rectangle 79"/>
              <p:cNvSpPr/>
              <p:nvPr/>
            </p:nvSpPr>
            <p:spPr>
              <a:xfrm>
                <a:off x="5711420" y="839234"/>
                <a:ext cx="54000" cy="54000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6" name="TextBox 85"/>
            <p:cNvSpPr txBox="1"/>
            <p:nvPr/>
          </p:nvSpPr>
          <p:spPr>
            <a:xfrm>
              <a:off x="3796018" y="3548399"/>
              <a:ext cx="3622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4247261" y="3602262"/>
              <a:ext cx="3809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4773997" y="3455933"/>
              <a:ext cx="3809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9" name="TextBox 88"/>
          <p:cNvSpPr txBox="1"/>
          <p:nvPr/>
        </p:nvSpPr>
        <p:spPr>
          <a:xfrm>
            <a:off x="3832473" y="5556610"/>
            <a:ext cx="3622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238766" y="5542992"/>
            <a:ext cx="3809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4779874" y="5428272"/>
            <a:ext cx="3809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5319441" y="5026770"/>
            <a:ext cx="3622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6950166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02</TotalTime>
  <Words>134</Words>
  <Application>Microsoft Office PowerPoint</Application>
  <PresentationFormat>A4 Paper (210x297 mm)</PresentationFormat>
  <Paragraphs>8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chi Patel</dc:creator>
  <cp:lastModifiedBy>0004394</cp:lastModifiedBy>
  <cp:revision>239</cp:revision>
  <cp:lastPrinted>2016-09-28T16:40:19Z</cp:lastPrinted>
  <dcterms:created xsi:type="dcterms:W3CDTF">2014-05-16T14:00:08Z</dcterms:created>
  <dcterms:modified xsi:type="dcterms:W3CDTF">2016-11-22T05:18:02Z</dcterms:modified>
</cp:coreProperties>
</file>